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63239C-6C19-4BED-82C0-916DC29B306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8F8EB5-CB2E-4D08-ADFB-C570076F18A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1AD7B-24D2-4DB7-BF09-6A6ADB9108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38427-23C8-4EDC-97D6-9AE493BC30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0DC44-2E87-4105-A98F-FD1B8AF63B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2B99F-0207-4383-A871-526DF64F3A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BDB2B-E3C5-4EDB-8BCB-A3270B2120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89043-D1C9-464C-96C0-CD764DC10A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95A4C6-CC6F-44D7-9603-792BD7EB56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1909F-C08B-4B00-B307-DCB3A4AE3A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5087F-C2E4-4FBF-AF04-A636A56B1D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A51E1-8573-46CA-8AD4-4C66BBBE3D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FF5C3-E888-434A-A25F-5DF46FC64B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07E38-B548-4CC6-8C21-75F9682A60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B53F64-9F6A-4A39-ABF0-C9295F7BE27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3"/>
          <p:cNvSpPr/>
          <p:nvPr/>
        </p:nvSpPr>
        <p:spPr>
          <a:xfrm>
            <a:off x="344880" y="4124160"/>
            <a:ext cx="842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Supplementary Figure 1: Commassie staining of the SDS PAG showing purified protein fractions of LigA, Pkn1 and Omp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15"/>
          <p:cNvGrpSpPr/>
          <p:nvPr/>
        </p:nvGrpSpPr>
        <p:grpSpPr>
          <a:xfrm>
            <a:off x="3344760" y="1773360"/>
            <a:ext cx="1852560" cy="2006640"/>
            <a:chOff x="3344760" y="1773360"/>
            <a:chExt cx="1852560" cy="2006640"/>
          </a:xfrm>
        </p:grpSpPr>
        <p:pic>
          <p:nvPicPr>
            <p:cNvPr id="50" name="Picture 2" descr=""/>
            <p:cNvPicPr/>
            <p:nvPr/>
          </p:nvPicPr>
          <p:blipFill>
            <a:blip r:embed="rId1"/>
            <a:srcRect l="32053" t="3035" r="53076" b="68189"/>
            <a:stretch/>
          </p:blipFill>
          <p:spPr>
            <a:xfrm>
              <a:off x="3851280" y="2749320"/>
              <a:ext cx="1296000" cy="50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2" descr=""/>
            <p:cNvPicPr/>
            <p:nvPr/>
          </p:nvPicPr>
          <p:blipFill>
            <a:blip r:embed="rId2"/>
            <a:srcRect l="6679" t="6056" r="77136" b="68189"/>
            <a:stretch/>
          </p:blipFill>
          <p:spPr>
            <a:xfrm flipH="1">
              <a:off x="3851280" y="3285720"/>
              <a:ext cx="1332000" cy="494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2" descr=""/>
            <p:cNvPicPr/>
            <p:nvPr/>
          </p:nvPicPr>
          <p:blipFill>
            <a:blip r:embed="rId3"/>
            <a:srcRect l="57427" t="3035" r="26826" b="72741"/>
            <a:stretch/>
          </p:blipFill>
          <p:spPr>
            <a:xfrm>
              <a:off x="3815280" y="2169360"/>
              <a:ext cx="1382040" cy="56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Box 6"/>
            <p:cNvSpPr/>
            <p:nvPr/>
          </p:nvSpPr>
          <p:spPr>
            <a:xfrm>
              <a:off x="3855960" y="1773360"/>
              <a:ext cx="6426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urified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ote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7"/>
            <p:cNvSpPr/>
            <p:nvPr/>
          </p:nvSpPr>
          <p:spPr>
            <a:xfrm>
              <a:off x="4534560" y="1773360"/>
              <a:ext cx="57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ark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8"/>
            <p:cNvSpPr/>
            <p:nvPr/>
          </p:nvSpPr>
          <p:spPr>
            <a:xfrm>
              <a:off x="3344760" y="2273400"/>
              <a:ext cx="546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ig A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8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0"/>
            <p:cNvSpPr/>
            <p:nvPr/>
          </p:nvSpPr>
          <p:spPr>
            <a:xfrm>
              <a:off x="3380400" y="2817360"/>
              <a:ext cx="546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kn1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0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1"/>
            <p:cNvSpPr/>
            <p:nvPr/>
          </p:nvSpPr>
          <p:spPr>
            <a:xfrm>
              <a:off x="3350520" y="3348000"/>
              <a:ext cx="546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Omp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5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TextBox 7"/>
          <p:cNvSpPr/>
          <p:nvPr/>
        </p:nvSpPr>
        <p:spPr>
          <a:xfrm>
            <a:off x="3734280" y="765000"/>
            <a:ext cx="165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27T17:03:11Z</dcterms:created>
  <dc:creator>NIDHI</dc:creator>
  <dc:description/>
  <dc:language>en-US</dc:language>
  <cp:lastModifiedBy>NIDHI</cp:lastModifiedBy>
  <dcterms:modified xsi:type="dcterms:W3CDTF">2014-05-30T03:55:50Z</dcterms:modified>
  <cp:revision>15</cp:revision>
  <dc:subject/>
  <dc:title>Slide 1</dc:title>
</cp:coreProperties>
</file>